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1520488" cy="6119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77" y="2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40061" y="1001553"/>
            <a:ext cx="8640366" cy="2130602"/>
          </a:xfrm>
        </p:spPr>
        <p:txBody>
          <a:bodyPr anchor="b"/>
          <a:lstStyle>
            <a:lvl1pPr algn="ctr">
              <a:defRPr sz="535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0061" y="3214319"/>
            <a:ext cx="8640366" cy="1477538"/>
          </a:xfrm>
        </p:spPr>
        <p:txBody>
          <a:bodyPr/>
          <a:lstStyle>
            <a:lvl1pPr marL="0" indent="0" algn="ctr">
              <a:buNone/>
              <a:defRPr sz="2142"/>
            </a:lvl1pPr>
            <a:lvl2pPr marL="408005" indent="0" algn="ctr">
              <a:buNone/>
              <a:defRPr sz="1785"/>
            </a:lvl2pPr>
            <a:lvl3pPr marL="816011" indent="0" algn="ctr">
              <a:buNone/>
              <a:defRPr sz="1606"/>
            </a:lvl3pPr>
            <a:lvl4pPr marL="1224016" indent="0" algn="ctr">
              <a:buNone/>
              <a:defRPr sz="1428"/>
            </a:lvl4pPr>
            <a:lvl5pPr marL="1632021" indent="0" algn="ctr">
              <a:buNone/>
              <a:defRPr sz="1428"/>
            </a:lvl5pPr>
            <a:lvl6pPr marL="2040026" indent="0" algn="ctr">
              <a:buNone/>
              <a:defRPr sz="1428"/>
            </a:lvl6pPr>
            <a:lvl7pPr marL="2448032" indent="0" algn="ctr">
              <a:buNone/>
              <a:defRPr sz="1428"/>
            </a:lvl7pPr>
            <a:lvl8pPr marL="2856037" indent="0" algn="ctr">
              <a:buNone/>
              <a:defRPr sz="1428"/>
            </a:lvl8pPr>
            <a:lvl9pPr marL="3264042" indent="0" algn="ctr">
              <a:buNone/>
              <a:defRPr sz="1428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409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5151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244349" y="325823"/>
            <a:ext cx="2484105" cy="518625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92033" y="325823"/>
            <a:ext cx="7308310" cy="518625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326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04723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6033" y="1525704"/>
            <a:ext cx="9936421" cy="2545672"/>
          </a:xfrm>
        </p:spPr>
        <p:txBody>
          <a:bodyPr anchor="b"/>
          <a:lstStyle>
            <a:lvl1pPr>
              <a:defRPr sz="535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6033" y="4095459"/>
            <a:ext cx="9936421" cy="1338709"/>
          </a:xfrm>
        </p:spPr>
        <p:txBody>
          <a:bodyPr/>
          <a:lstStyle>
            <a:lvl1pPr marL="0" indent="0">
              <a:buNone/>
              <a:defRPr sz="2142">
                <a:solidFill>
                  <a:schemeClr val="tx1">
                    <a:tint val="75000"/>
                  </a:schemeClr>
                </a:solidFill>
              </a:defRPr>
            </a:lvl1pPr>
            <a:lvl2pPr marL="408005" indent="0">
              <a:buNone/>
              <a:defRPr sz="1785">
                <a:solidFill>
                  <a:schemeClr val="tx1">
                    <a:tint val="75000"/>
                  </a:schemeClr>
                </a:solidFill>
              </a:defRPr>
            </a:lvl2pPr>
            <a:lvl3pPr marL="816011" indent="0">
              <a:buNone/>
              <a:defRPr sz="1606">
                <a:solidFill>
                  <a:schemeClr val="tx1">
                    <a:tint val="75000"/>
                  </a:schemeClr>
                </a:solidFill>
              </a:defRPr>
            </a:lvl3pPr>
            <a:lvl4pPr marL="1224016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4pPr>
            <a:lvl5pPr marL="1632021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5pPr>
            <a:lvl6pPr marL="2040026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6pPr>
            <a:lvl7pPr marL="2448032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7pPr>
            <a:lvl8pPr marL="2856037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8pPr>
            <a:lvl9pPr marL="3264042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8050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92034" y="1629117"/>
            <a:ext cx="4896207" cy="3882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32247" y="1629117"/>
            <a:ext cx="4896207" cy="3882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706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4" y="325824"/>
            <a:ext cx="9936421" cy="118288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3535" y="1500205"/>
            <a:ext cx="4873706" cy="735227"/>
          </a:xfrm>
        </p:spPr>
        <p:txBody>
          <a:bodyPr anchor="b"/>
          <a:lstStyle>
            <a:lvl1pPr marL="0" indent="0">
              <a:buNone/>
              <a:defRPr sz="2142" b="1"/>
            </a:lvl1pPr>
            <a:lvl2pPr marL="408005" indent="0">
              <a:buNone/>
              <a:defRPr sz="1785" b="1"/>
            </a:lvl2pPr>
            <a:lvl3pPr marL="816011" indent="0">
              <a:buNone/>
              <a:defRPr sz="1606" b="1"/>
            </a:lvl3pPr>
            <a:lvl4pPr marL="1224016" indent="0">
              <a:buNone/>
              <a:defRPr sz="1428" b="1"/>
            </a:lvl4pPr>
            <a:lvl5pPr marL="1632021" indent="0">
              <a:buNone/>
              <a:defRPr sz="1428" b="1"/>
            </a:lvl5pPr>
            <a:lvl6pPr marL="2040026" indent="0">
              <a:buNone/>
              <a:defRPr sz="1428" b="1"/>
            </a:lvl6pPr>
            <a:lvl7pPr marL="2448032" indent="0">
              <a:buNone/>
              <a:defRPr sz="1428" b="1"/>
            </a:lvl7pPr>
            <a:lvl8pPr marL="2856037" indent="0">
              <a:buNone/>
              <a:defRPr sz="1428" b="1"/>
            </a:lvl8pPr>
            <a:lvl9pPr marL="3264042" indent="0">
              <a:buNone/>
              <a:defRPr sz="142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93535" y="2235432"/>
            <a:ext cx="4873706" cy="32879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32247" y="1500205"/>
            <a:ext cx="4897708" cy="735227"/>
          </a:xfrm>
        </p:spPr>
        <p:txBody>
          <a:bodyPr anchor="b"/>
          <a:lstStyle>
            <a:lvl1pPr marL="0" indent="0">
              <a:buNone/>
              <a:defRPr sz="2142" b="1"/>
            </a:lvl1pPr>
            <a:lvl2pPr marL="408005" indent="0">
              <a:buNone/>
              <a:defRPr sz="1785" b="1"/>
            </a:lvl2pPr>
            <a:lvl3pPr marL="816011" indent="0">
              <a:buNone/>
              <a:defRPr sz="1606" b="1"/>
            </a:lvl3pPr>
            <a:lvl4pPr marL="1224016" indent="0">
              <a:buNone/>
              <a:defRPr sz="1428" b="1"/>
            </a:lvl4pPr>
            <a:lvl5pPr marL="1632021" indent="0">
              <a:buNone/>
              <a:defRPr sz="1428" b="1"/>
            </a:lvl5pPr>
            <a:lvl6pPr marL="2040026" indent="0">
              <a:buNone/>
              <a:defRPr sz="1428" b="1"/>
            </a:lvl6pPr>
            <a:lvl7pPr marL="2448032" indent="0">
              <a:buNone/>
              <a:defRPr sz="1428" b="1"/>
            </a:lvl7pPr>
            <a:lvl8pPr marL="2856037" indent="0">
              <a:buNone/>
              <a:defRPr sz="1428" b="1"/>
            </a:lvl8pPr>
            <a:lvl9pPr marL="3264042" indent="0">
              <a:buNone/>
              <a:defRPr sz="1428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832247" y="2235432"/>
            <a:ext cx="4897708" cy="32879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4183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168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4025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5" y="407988"/>
            <a:ext cx="3715657" cy="1427956"/>
          </a:xfrm>
        </p:spPr>
        <p:txBody>
          <a:bodyPr anchor="b"/>
          <a:lstStyle>
            <a:lvl1pPr>
              <a:defRPr sz="285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97708" y="881140"/>
            <a:ext cx="5832247" cy="4349034"/>
          </a:xfrm>
        </p:spPr>
        <p:txBody>
          <a:bodyPr/>
          <a:lstStyle>
            <a:lvl1pPr>
              <a:defRPr sz="2856"/>
            </a:lvl1pPr>
            <a:lvl2pPr>
              <a:defRPr sz="2499"/>
            </a:lvl2pPr>
            <a:lvl3pPr>
              <a:defRPr sz="2142"/>
            </a:lvl3pPr>
            <a:lvl4pPr>
              <a:defRPr sz="1785"/>
            </a:lvl4pPr>
            <a:lvl5pPr>
              <a:defRPr sz="1785"/>
            </a:lvl5pPr>
            <a:lvl6pPr>
              <a:defRPr sz="1785"/>
            </a:lvl6pPr>
            <a:lvl7pPr>
              <a:defRPr sz="1785"/>
            </a:lvl7pPr>
            <a:lvl8pPr>
              <a:defRPr sz="1785"/>
            </a:lvl8pPr>
            <a:lvl9pPr>
              <a:defRPr sz="178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93535" y="1835944"/>
            <a:ext cx="3715657" cy="3401313"/>
          </a:xfrm>
        </p:spPr>
        <p:txBody>
          <a:bodyPr/>
          <a:lstStyle>
            <a:lvl1pPr marL="0" indent="0">
              <a:buNone/>
              <a:defRPr sz="1428"/>
            </a:lvl1pPr>
            <a:lvl2pPr marL="408005" indent="0">
              <a:buNone/>
              <a:defRPr sz="1249"/>
            </a:lvl2pPr>
            <a:lvl3pPr marL="816011" indent="0">
              <a:buNone/>
              <a:defRPr sz="1071"/>
            </a:lvl3pPr>
            <a:lvl4pPr marL="1224016" indent="0">
              <a:buNone/>
              <a:defRPr sz="892"/>
            </a:lvl4pPr>
            <a:lvl5pPr marL="1632021" indent="0">
              <a:buNone/>
              <a:defRPr sz="892"/>
            </a:lvl5pPr>
            <a:lvl6pPr marL="2040026" indent="0">
              <a:buNone/>
              <a:defRPr sz="892"/>
            </a:lvl6pPr>
            <a:lvl7pPr marL="2448032" indent="0">
              <a:buNone/>
              <a:defRPr sz="892"/>
            </a:lvl7pPr>
            <a:lvl8pPr marL="2856037" indent="0">
              <a:buNone/>
              <a:defRPr sz="892"/>
            </a:lvl8pPr>
            <a:lvl9pPr marL="3264042" indent="0">
              <a:buNone/>
              <a:defRPr sz="89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3522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5" y="407988"/>
            <a:ext cx="3715657" cy="1427956"/>
          </a:xfrm>
        </p:spPr>
        <p:txBody>
          <a:bodyPr anchor="b"/>
          <a:lstStyle>
            <a:lvl1pPr>
              <a:defRPr sz="285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897708" y="881140"/>
            <a:ext cx="5832247" cy="4349034"/>
          </a:xfrm>
        </p:spPr>
        <p:txBody>
          <a:bodyPr anchor="t"/>
          <a:lstStyle>
            <a:lvl1pPr marL="0" indent="0">
              <a:buNone/>
              <a:defRPr sz="2856"/>
            </a:lvl1pPr>
            <a:lvl2pPr marL="408005" indent="0">
              <a:buNone/>
              <a:defRPr sz="2499"/>
            </a:lvl2pPr>
            <a:lvl3pPr marL="816011" indent="0">
              <a:buNone/>
              <a:defRPr sz="2142"/>
            </a:lvl3pPr>
            <a:lvl4pPr marL="1224016" indent="0">
              <a:buNone/>
              <a:defRPr sz="1785"/>
            </a:lvl4pPr>
            <a:lvl5pPr marL="1632021" indent="0">
              <a:buNone/>
              <a:defRPr sz="1785"/>
            </a:lvl5pPr>
            <a:lvl6pPr marL="2040026" indent="0">
              <a:buNone/>
              <a:defRPr sz="1785"/>
            </a:lvl6pPr>
            <a:lvl7pPr marL="2448032" indent="0">
              <a:buNone/>
              <a:defRPr sz="1785"/>
            </a:lvl7pPr>
            <a:lvl8pPr marL="2856037" indent="0">
              <a:buNone/>
              <a:defRPr sz="1785"/>
            </a:lvl8pPr>
            <a:lvl9pPr marL="3264042" indent="0">
              <a:buNone/>
              <a:defRPr sz="178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93535" y="1835944"/>
            <a:ext cx="3715657" cy="3401313"/>
          </a:xfrm>
        </p:spPr>
        <p:txBody>
          <a:bodyPr/>
          <a:lstStyle>
            <a:lvl1pPr marL="0" indent="0">
              <a:buNone/>
              <a:defRPr sz="1428"/>
            </a:lvl1pPr>
            <a:lvl2pPr marL="408005" indent="0">
              <a:buNone/>
              <a:defRPr sz="1249"/>
            </a:lvl2pPr>
            <a:lvl3pPr marL="816011" indent="0">
              <a:buNone/>
              <a:defRPr sz="1071"/>
            </a:lvl3pPr>
            <a:lvl4pPr marL="1224016" indent="0">
              <a:buNone/>
              <a:defRPr sz="892"/>
            </a:lvl4pPr>
            <a:lvl5pPr marL="1632021" indent="0">
              <a:buNone/>
              <a:defRPr sz="892"/>
            </a:lvl5pPr>
            <a:lvl6pPr marL="2040026" indent="0">
              <a:buNone/>
              <a:defRPr sz="892"/>
            </a:lvl6pPr>
            <a:lvl7pPr marL="2448032" indent="0">
              <a:buNone/>
              <a:defRPr sz="892"/>
            </a:lvl7pPr>
            <a:lvl8pPr marL="2856037" indent="0">
              <a:buNone/>
              <a:defRPr sz="892"/>
            </a:lvl8pPr>
            <a:lvl9pPr marL="3264042" indent="0">
              <a:buNone/>
              <a:defRPr sz="89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4286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92034" y="325824"/>
            <a:ext cx="9936421" cy="1182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2034" y="1629117"/>
            <a:ext cx="9936421" cy="38829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92033" y="5672161"/>
            <a:ext cx="2592110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993EBB-D870-4C27-99A1-7CFB54AA8A56}" type="datetimeFigureOut">
              <a:rPr kumimoji="1" lang="ja-JP" altLang="en-US" smtClean="0"/>
              <a:t>2022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16162" y="5672161"/>
            <a:ext cx="3888165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136345" y="5672161"/>
            <a:ext cx="2592110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A035D-B828-4A6C-8088-DC56E454B1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5646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16011" rtl="0" eaLnBrk="1" latinLnBrk="0" hangingPunct="1">
        <a:lnSpc>
          <a:spcPct val="90000"/>
        </a:lnSpc>
        <a:spcBef>
          <a:spcPct val="0"/>
        </a:spcBef>
        <a:buNone/>
        <a:defRPr kumimoji="1" sz="392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4003" indent="-204003" algn="l" defTabSz="816011" rtl="0" eaLnBrk="1" latinLnBrk="0" hangingPunct="1">
        <a:lnSpc>
          <a:spcPct val="90000"/>
        </a:lnSpc>
        <a:spcBef>
          <a:spcPts val="892"/>
        </a:spcBef>
        <a:buFont typeface="Arial" panose="020B0604020202020204" pitchFamily="34" charset="0"/>
        <a:buChar char="•"/>
        <a:defRPr kumimoji="1" sz="2499" kern="1200">
          <a:solidFill>
            <a:schemeClr val="tx1"/>
          </a:solidFill>
          <a:latin typeface="+mn-lt"/>
          <a:ea typeface="+mn-ea"/>
          <a:cs typeface="+mn-cs"/>
        </a:defRPr>
      </a:lvl1pPr>
      <a:lvl2pPr marL="612008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2142" kern="1200">
          <a:solidFill>
            <a:schemeClr val="tx1"/>
          </a:solidFill>
          <a:latin typeface="+mn-lt"/>
          <a:ea typeface="+mn-ea"/>
          <a:cs typeface="+mn-cs"/>
        </a:defRPr>
      </a:lvl2pPr>
      <a:lvl3pPr marL="1020013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785" kern="1200">
          <a:solidFill>
            <a:schemeClr val="tx1"/>
          </a:solidFill>
          <a:latin typeface="+mn-lt"/>
          <a:ea typeface="+mn-ea"/>
          <a:cs typeface="+mn-cs"/>
        </a:defRPr>
      </a:lvl3pPr>
      <a:lvl4pPr marL="1428018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4pPr>
      <a:lvl5pPr marL="1836024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5pPr>
      <a:lvl6pPr marL="2244029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6pPr>
      <a:lvl7pPr marL="2652034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7pPr>
      <a:lvl8pPr marL="3060040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8pPr>
      <a:lvl9pPr marL="3468045" indent="-204003" algn="l" defTabSz="816011" rtl="0" eaLnBrk="1" latinLnBrk="0" hangingPunct="1">
        <a:lnSpc>
          <a:spcPct val="90000"/>
        </a:lnSpc>
        <a:spcBef>
          <a:spcPts val="446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1pPr>
      <a:lvl2pPr marL="408005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816011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3pPr>
      <a:lvl4pPr marL="1224016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4pPr>
      <a:lvl5pPr marL="1632021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5pPr>
      <a:lvl6pPr marL="2040026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6pPr>
      <a:lvl7pPr marL="2448032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7pPr>
      <a:lvl8pPr marL="2856037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8pPr>
      <a:lvl9pPr marL="3264042" algn="l" defTabSz="816011" rtl="0" eaLnBrk="1" latinLnBrk="0" hangingPunct="1"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1DF6D757-B471-9CD3-39C3-894482A069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2452" y="803501"/>
            <a:ext cx="5291666" cy="380999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63D9D587-D752-7853-73D0-82352FEC61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85854" y="810111"/>
            <a:ext cx="5291667" cy="379677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7A025D7-534F-A119-004A-9C6B958B5320}"/>
              </a:ext>
            </a:extLst>
          </p:cNvPr>
          <p:cNvSpPr txBox="1"/>
          <p:nvPr/>
        </p:nvSpPr>
        <p:spPr>
          <a:xfrm>
            <a:off x="472452" y="165023"/>
            <a:ext cx="41773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0BD8676-1A9D-9DB4-D8CA-BE478B76F444}"/>
              </a:ext>
            </a:extLst>
          </p:cNvPr>
          <p:cNvSpPr txBox="1"/>
          <p:nvPr/>
        </p:nvSpPr>
        <p:spPr>
          <a:xfrm>
            <a:off x="6246006" y="165023"/>
            <a:ext cx="41773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F72388C-1B7F-6EAA-7016-E94060A034DB}"/>
              </a:ext>
            </a:extLst>
          </p:cNvPr>
          <p:cNvSpPr txBox="1"/>
          <p:nvPr/>
        </p:nvSpPr>
        <p:spPr>
          <a:xfrm rot="16200000">
            <a:off x="-1424798" y="2523830"/>
            <a:ext cx="3425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T (U/L)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64801F0-4556-4075-BEEF-F6C94A856245}"/>
              </a:ext>
            </a:extLst>
          </p:cNvPr>
          <p:cNvSpPr txBox="1"/>
          <p:nvPr/>
        </p:nvSpPr>
        <p:spPr>
          <a:xfrm rot="16200000">
            <a:off x="4236201" y="2523831"/>
            <a:ext cx="3425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T (U/L)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7D8956C-171C-C05E-9D8C-BF98A87C6805}"/>
              </a:ext>
            </a:extLst>
          </p:cNvPr>
          <p:cNvSpPr txBox="1"/>
          <p:nvPr/>
        </p:nvSpPr>
        <p:spPr>
          <a:xfrm>
            <a:off x="560505" y="4853365"/>
            <a:ext cx="107422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 plots of ALT levels in glucoraphanin and placebo group.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ALT levels in glucoraphanin group, (B) ALT levels in placebo group.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yellow-colored range indicated the ALT inclusion criteria (31≤ ALT≤50 U/L).</a:t>
            </a:r>
          </a:p>
        </p:txBody>
      </p:sp>
    </p:spTree>
    <p:extLst>
      <p:ext uri="{BB962C8B-B14F-4D97-AF65-F5344CB8AC3E}">
        <p14:creationId xmlns:p14="http://schemas.microsoft.com/office/powerpoint/2010/main" val="439855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69</Words>
  <Application>Microsoft Office PowerPoint</Application>
  <PresentationFormat>ユーザー設定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里見 翔平(Shohei Satomi)</dc:creator>
  <cp:lastModifiedBy>里見 翔平(Shohei Satomi)</cp:lastModifiedBy>
  <cp:revision>2</cp:revision>
  <dcterms:created xsi:type="dcterms:W3CDTF">2022-11-30T07:13:19Z</dcterms:created>
  <dcterms:modified xsi:type="dcterms:W3CDTF">2022-12-05T00:35:55Z</dcterms:modified>
</cp:coreProperties>
</file>